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F25F1"/>
    <a:srgbClr val="0D20D7"/>
    <a:srgbClr val="FFFFFF"/>
    <a:srgbClr val="4D1C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58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6420E7-39CF-479F-9752-54A2C53F58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068DBD0-78C6-4879-9894-B1AB4B3D83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242C6B-98A9-447B-B8EC-3E27D6633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92DEF69-8522-405F-B79D-8364B785E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163B84-EDBF-43F7-A7D7-425934633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718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EB3C51-5BD5-42F5-9694-D8970C5C00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294886D-A076-4F5B-B063-9A7BD3CE23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37BF7F-5FDA-4FE1-B7F0-1FA87B40A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2254C4-A962-4EAD-907E-353E83136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C58E34-D009-4D07-B151-5B6F73C3F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9340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2A2B564-6A55-4A26-A1C5-8B0644C2CB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A37F7D2-D93A-4A8F-8BB3-C557534145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CDD2F2-CE8F-4F3E-A889-67D7C80915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E8FD5F-F997-4D92-ACFA-4EC2D710F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923D75-76BD-4E3C-A020-8BC5AA0E7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1552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E3E97D-9E2D-4FAA-ADC7-00032BB783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4159491-7F45-474E-A2E1-21259103C2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8C1C69-8766-490E-BE5B-99E35B0ED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B1EA92-9A39-48B8-B176-429F785E6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3092B37-EF02-4BFC-B438-FADF1DDDC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6133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09B5A7-8F55-4A04-9DDA-9E67ABEE4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175B0A-CD0F-4645-B878-0273E15877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AE926D-F149-4A13-BD49-F9EF9B237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61A184-4E3E-42B3-88C8-6A385B05A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32D4C78-C6DE-424C-856A-E086CDABA9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4410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13FF31-B072-4D7F-94D5-1E9BC16036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4ABD9C1-BEAB-4956-A963-63FA6736B7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AFE7B6A-E8D5-4866-8CAC-899BAB8098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2F6089F-F0DE-456F-AE52-CF74BB138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065A2CA-94A0-4CB6-AEF5-B3A4C508E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820A4DA-310D-4DE6-A61C-C38DAEAFA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9020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1735DC-CED1-45ED-B8A2-5E1D1D281A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95441DD-FB7B-46A3-AF11-09B93661D4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6BFA22F-39F3-4203-9AA8-F3A5E602CB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DD560C6-24D6-45BD-8993-DFE973DD7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9E82F0D-AA99-4739-B582-7D78204CA8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1D60C49-01FA-4CBF-8F41-137257904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6B1176D-0878-4546-B915-F99703D86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1388947-51CA-4518-B27D-D84A9E1F6A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9219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A8C5D1-A1C9-47A8-8CC7-CA17941C50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B453D13-CCE3-4EEF-BBDD-2308FADF0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CFEAE3D-5810-428A-9170-1D4E1542F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4FE0BE7-D228-45EC-AD2C-2E894BEF1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5175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D5B82EC-B854-4048-8B12-31D00BB51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8BA0CE1-B2D5-4DF4-B587-5E9427444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3BCCD4C-095B-4755-B9EE-A44742B32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3285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8E1A0F-1E73-4B16-A23B-B83FEF6C2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9FDEE8-F6E6-49E7-A408-DA9090D2D2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9F1B3D8-E825-499B-B202-224F65121D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F6EE1AF-7852-4A2D-A5E9-30A30BD6E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64485F-8CDA-4E25-A61E-4FC0C6F5D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1CDB103-F627-40BB-9E1E-7F515EA6F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355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521B7C-7732-4083-BDE7-2D1A9CC50C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9F4E07B-C373-4C17-B6F2-E9F7AB3F2A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D40D64A-CE58-4643-B300-85EB1318E3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D97A78-AA1E-48FD-8AF9-46BB9060D3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1D0282B-A350-4DA4-A1BE-0D6C3653F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E1547B8-6C14-49CE-BE9F-34ABF270B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230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BF5FDA4-4788-44DC-818F-CBEF480C90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9317D16-12E1-49D4-A406-D5FDDD9730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E2BC99-3D41-44E1-800E-500017898B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402764-2178-4E16-AF9D-DCF9B08D91C3}" type="datetimeFigureOut">
              <a:rPr lang="zh-CN" altLang="en-US" smtClean="0"/>
              <a:t>2019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7F78FE-C944-471B-B6DB-FDF5BD920E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07040F-4CA6-471F-80DD-C133022C8D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B99F9E-B6EF-4FAD-B074-2DC19217DC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3808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emf"/><Relationship Id="rId3" Type="http://schemas.openxmlformats.org/officeDocument/2006/relationships/image" Target="../media/image2.png"/><Relationship Id="rId21" Type="http://schemas.openxmlformats.org/officeDocument/2006/relationships/image" Target="../media/image20.emf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emf"/><Relationship Id="rId25" Type="http://schemas.openxmlformats.org/officeDocument/2006/relationships/image" Target="../media/image24.emf"/><Relationship Id="rId2" Type="http://schemas.openxmlformats.org/officeDocument/2006/relationships/image" Target="../media/image1.png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emf"/><Relationship Id="rId5" Type="http://schemas.openxmlformats.org/officeDocument/2006/relationships/image" Target="../media/image4.png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10" Type="http://schemas.openxmlformats.org/officeDocument/2006/relationships/image" Target="../media/image9.png"/><Relationship Id="rId19" Type="http://schemas.openxmlformats.org/officeDocument/2006/relationships/image" Target="../media/image18.emf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emf"/><Relationship Id="rId22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E95C887-44D7-41B6-AD0C-6B38356CDC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289" y="197999"/>
            <a:ext cx="2323265" cy="180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3B232D08-5F49-4F14-A36E-00521D806D6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3290" y="180000"/>
            <a:ext cx="2321161" cy="180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93B0C971-1994-4181-B59E-2C2E2F2C0A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3290" y="180001"/>
            <a:ext cx="2314223" cy="1800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B4F65041-6C9C-400E-A1E4-5595216EF5FC}"/>
              </a:ext>
            </a:extLst>
          </p:cNvPr>
          <p:cNvSpPr txBox="1"/>
          <p:nvPr/>
        </p:nvSpPr>
        <p:spPr>
          <a:xfrm>
            <a:off x="9179672" y="1998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ophageal Adenocarcinoma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5FDF8DB7-21A6-45F8-AC37-83A8FE2CF90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3289" y="180001"/>
            <a:ext cx="2235875" cy="1800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A5EDA1D9-0675-4663-8A5E-B31B80CE77F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3291" y="2340000"/>
            <a:ext cx="2223055" cy="18000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50EE91A8-94BD-4D2B-9F77-BA39FD48C7F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3290" y="2340000"/>
            <a:ext cx="2238565" cy="180000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40C96AB4-470F-4059-9BC1-4104725B935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3291" y="2340000"/>
            <a:ext cx="2236526" cy="180000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8AC84FDD-492C-4969-98C7-B2E2139A77E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290" y="4500000"/>
            <a:ext cx="2244610" cy="18000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6363A3F4-60B6-4C1C-84BF-A2C4F646DDD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3291" y="4500000"/>
            <a:ext cx="2250675" cy="180000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C985420C-4733-497B-A7D9-21900B72646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3291" y="4500000"/>
            <a:ext cx="2245947" cy="1800000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44B68347-18B0-4EAB-9EE9-401298310B4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13291" y="4499999"/>
            <a:ext cx="2245249" cy="1800000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24910FF9-F255-45FF-83BF-EC58CF394F6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289" y="2340000"/>
            <a:ext cx="2305065" cy="1800000"/>
          </a:xfrm>
          <a:prstGeom prst="rect">
            <a:avLst/>
          </a:prstGeom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6A23E5D3-ED39-4D09-ABF7-BEEDFD7E4D7B}"/>
              </a:ext>
            </a:extLst>
          </p:cNvPr>
          <p:cNvSpPr txBox="1"/>
          <p:nvPr/>
        </p:nvSpPr>
        <p:spPr>
          <a:xfrm>
            <a:off x="9180000" y="4140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Hepatocellular Carcinoma 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E011AFBB-D1E3-40B2-86E8-679B5195AB63}"/>
              </a:ext>
            </a:extLst>
          </p:cNvPr>
          <p:cNvSpPr txBox="1"/>
          <p:nvPr/>
        </p:nvSpPr>
        <p:spPr>
          <a:xfrm>
            <a:off x="9180000" y="6300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rcoma 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939018C3-B66A-4B60-AD99-9361CD02AB1B}"/>
              </a:ext>
            </a:extLst>
          </p:cNvPr>
          <p:cNvSpPr txBox="1"/>
          <p:nvPr/>
        </p:nvSpPr>
        <p:spPr>
          <a:xfrm>
            <a:off x="588045" y="1998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adder Urothelial Carcinoma 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A5AB34EF-14D9-449B-BD31-5AA36C4F09DE}"/>
              </a:ext>
            </a:extLst>
          </p:cNvPr>
          <p:cNvSpPr txBox="1"/>
          <p:nvPr/>
        </p:nvSpPr>
        <p:spPr>
          <a:xfrm>
            <a:off x="3465306" y="1998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adder Urothelial Carcinoma 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31BE3A32-70BB-48F2-88E8-BAD35C5F726B}"/>
              </a:ext>
            </a:extLst>
          </p:cNvPr>
          <p:cNvSpPr txBox="1"/>
          <p:nvPr/>
        </p:nvSpPr>
        <p:spPr>
          <a:xfrm>
            <a:off x="6348371" y="1998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ophageal Adenocarcinoma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4924647A-89D9-4109-B93D-107DF3052871}"/>
              </a:ext>
            </a:extLst>
          </p:cNvPr>
          <p:cNvSpPr txBox="1"/>
          <p:nvPr/>
        </p:nvSpPr>
        <p:spPr>
          <a:xfrm>
            <a:off x="586800" y="6300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Hepatocellular Carcinoma 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96676F60-5907-4F21-AF2E-B788BFA362BE}"/>
              </a:ext>
            </a:extLst>
          </p:cNvPr>
          <p:cNvSpPr txBox="1"/>
          <p:nvPr/>
        </p:nvSpPr>
        <p:spPr>
          <a:xfrm>
            <a:off x="586800" y="4139999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ioblastoma Multiforme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217C3E65-CD48-4FB5-B70B-98E38C250916}"/>
              </a:ext>
            </a:extLst>
          </p:cNvPr>
          <p:cNvSpPr txBox="1"/>
          <p:nvPr/>
        </p:nvSpPr>
        <p:spPr>
          <a:xfrm>
            <a:off x="6346800" y="4140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Hepatocellular Carcinoma 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6B3C4CC-F2E4-4623-B0C8-7588522DE313}"/>
              </a:ext>
            </a:extLst>
          </p:cNvPr>
          <p:cNvSpPr txBox="1"/>
          <p:nvPr/>
        </p:nvSpPr>
        <p:spPr>
          <a:xfrm>
            <a:off x="3466800" y="4140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d and Neck Squamous Cell Carcinoma 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01C4E67-DBA3-4EB4-9368-4F792C7416D4}"/>
              </a:ext>
            </a:extLst>
          </p:cNvPr>
          <p:cNvSpPr txBox="1"/>
          <p:nvPr/>
        </p:nvSpPr>
        <p:spPr>
          <a:xfrm>
            <a:off x="6346800" y="6300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state Adenocarcinoma 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7E020BC7-3F50-4A7F-B5C3-05A23D06954B}"/>
              </a:ext>
            </a:extLst>
          </p:cNvPr>
          <p:cNvSpPr txBox="1"/>
          <p:nvPr/>
        </p:nvSpPr>
        <p:spPr>
          <a:xfrm>
            <a:off x="3466800" y="6300000"/>
            <a:ext cx="25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creatic Adenocarcinoma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3713E90B-6C92-40CF-8CEA-94706F39BD2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200756" y="180000"/>
            <a:ext cx="2105149" cy="576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26E5267-5606-45CF-8187-770FC4FED06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082400" y="180000"/>
            <a:ext cx="2102929" cy="576000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D7C47831-96AF-4A18-B863-60B15C77151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962400" y="180000"/>
            <a:ext cx="2105149" cy="576000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93F24F12-6E07-4ACC-83A1-F668C9EA221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842400" y="180000"/>
            <a:ext cx="2105149" cy="576000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D8FAE26A-72B9-424E-A2AB-177B8C84764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200756" y="2340000"/>
            <a:ext cx="2105149" cy="576000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75A5C3FC-6007-4462-9A6A-1C9A2202A516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082400" y="2340000"/>
            <a:ext cx="2105149" cy="576000"/>
          </a:xfrm>
          <a:prstGeom prst="rect">
            <a:avLst/>
          </a:prstGeom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ED3C6901-DD63-4FB5-B349-E62F3B5D57A6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6962400" y="2340000"/>
            <a:ext cx="2105149" cy="576000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902460CB-2703-46D1-A347-EBE3CA6933C8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9842400" y="2340000"/>
            <a:ext cx="2105149" cy="576000"/>
          </a:xfrm>
          <a:prstGeom prst="rect">
            <a:avLst/>
          </a:prstGeom>
        </p:spPr>
      </p:pic>
      <p:pic>
        <p:nvPicPr>
          <p:cNvPr id="78" name="图片 77">
            <a:extLst>
              <a:ext uri="{FF2B5EF4-FFF2-40B4-BE49-F238E27FC236}">
                <a16:creationId xmlns:a16="http://schemas.microsoft.com/office/drawing/2014/main" id="{6DC69745-E947-463F-B5D5-F4DB4B3523FF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202400" y="4500000"/>
            <a:ext cx="2105149" cy="576000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:a16="http://schemas.microsoft.com/office/drawing/2014/main" id="{955DED23-4C37-46AF-B859-AD34548DF9E7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082400" y="4500000"/>
            <a:ext cx="2105149" cy="576000"/>
          </a:xfrm>
          <a:prstGeom prst="rect">
            <a:avLst/>
          </a:prstGeom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EA52035F-79F7-4640-BEEE-0AD6E4C8D2E8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6962400" y="5479321"/>
            <a:ext cx="2105149" cy="576000"/>
          </a:xfrm>
          <a:prstGeom prst="rect">
            <a:avLst/>
          </a:prstGeom>
        </p:spPr>
      </p:pic>
      <p:pic>
        <p:nvPicPr>
          <p:cNvPr id="87" name="图片 86">
            <a:extLst>
              <a:ext uri="{FF2B5EF4-FFF2-40B4-BE49-F238E27FC236}">
                <a16:creationId xmlns:a16="http://schemas.microsoft.com/office/drawing/2014/main" id="{A2E6EF12-BA6E-4DFF-AFEA-715D6904C9D8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9842400" y="4500000"/>
            <a:ext cx="2105149" cy="576000"/>
          </a:xfrm>
          <a:prstGeom prst="rect">
            <a:avLst/>
          </a:prstGeom>
        </p:spPr>
      </p:pic>
      <p:grpSp>
        <p:nvGrpSpPr>
          <p:cNvPr id="92" name="组合 91">
            <a:extLst>
              <a:ext uri="{FF2B5EF4-FFF2-40B4-BE49-F238E27FC236}">
                <a16:creationId xmlns:a16="http://schemas.microsoft.com/office/drawing/2014/main" id="{148FB54E-D259-4179-A6FF-9DBF47CF4888}"/>
              </a:ext>
            </a:extLst>
          </p:cNvPr>
          <p:cNvGrpSpPr/>
          <p:nvPr/>
        </p:nvGrpSpPr>
        <p:grpSpPr>
          <a:xfrm>
            <a:off x="8254148" y="6575753"/>
            <a:ext cx="3248127" cy="230832"/>
            <a:chOff x="3492317" y="6575753"/>
            <a:chExt cx="3248127" cy="230832"/>
          </a:xfrm>
        </p:grpSpPr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7A25A061-8BAA-49B4-92E9-3281518135C8}"/>
                </a:ext>
              </a:extLst>
            </p:cNvPr>
            <p:cNvSpPr txBox="1"/>
            <p:nvPr/>
          </p:nvSpPr>
          <p:spPr>
            <a:xfrm>
              <a:off x="3600000" y="6575753"/>
              <a:ext cx="12827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s with alteration(s)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93D470BB-1244-40CF-B52A-C740C00560EB}"/>
                </a:ext>
              </a:extLst>
            </p:cNvPr>
            <p:cNvSpPr txBox="1"/>
            <p:nvPr/>
          </p:nvSpPr>
          <p:spPr>
            <a:xfrm>
              <a:off x="5328000" y="6575753"/>
              <a:ext cx="141244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s without alteration(s)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矩形 89">
              <a:extLst>
                <a:ext uri="{FF2B5EF4-FFF2-40B4-BE49-F238E27FC236}">
                  <a16:creationId xmlns:a16="http://schemas.microsoft.com/office/drawing/2014/main" id="{725C5D70-5F1B-4B25-802B-DBC297BC9A34}"/>
                </a:ext>
              </a:extLst>
            </p:cNvPr>
            <p:cNvSpPr/>
            <p:nvPr/>
          </p:nvSpPr>
          <p:spPr>
            <a:xfrm>
              <a:off x="5220000" y="6661519"/>
              <a:ext cx="72000" cy="72000"/>
            </a:xfrm>
            <a:prstGeom prst="rect">
              <a:avLst/>
            </a:prstGeom>
            <a:solidFill>
              <a:srgbClr val="0F25F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1" name="矩形 90">
              <a:extLst>
                <a:ext uri="{FF2B5EF4-FFF2-40B4-BE49-F238E27FC236}">
                  <a16:creationId xmlns:a16="http://schemas.microsoft.com/office/drawing/2014/main" id="{D50B38D5-F2D5-48A0-8FD8-6C1ADA442369}"/>
                </a:ext>
              </a:extLst>
            </p:cNvPr>
            <p:cNvSpPr/>
            <p:nvPr/>
          </p:nvSpPr>
          <p:spPr>
            <a:xfrm>
              <a:off x="3492317" y="6660000"/>
              <a:ext cx="72000" cy="720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789831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5</TotalTime>
  <Words>44</Words>
  <Application>Microsoft Office PowerPoint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li</dc:creator>
  <cp:lastModifiedBy>lilyl</cp:lastModifiedBy>
  <cp:revision>16</cp:revision>
  <dcterms:created xsi:type="dcterms:W3CDTF">2018-05-23T16:08:53Z</dcterms:created>
  <dcterms:modified xsi:type="dcterms:W3CDTF">2019-03-29T10:36:09Z</dcterms:modified>
</cp:coreProperties>
</file>